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7315200" cy="6858000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30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79" d="100"/>
          <a:sy n="79" d="100"/>
        </p:scale>
        <p:origin x="1978" y="72"/>
      </p:cViewPr>
      <p:guideLst>
        <p:guide orient="horz" pos="2160"/>
        <p:guide pos="230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1122363"/>
            <a:ext cx="6217920" cy="2387600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3602038"/>
            <a:ext cx="5486400" cy="1655762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A0D80-483B-4B86-9E41-E82F57A7FC71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BFCB-6F1D-41F8-A75E-A6FFB068C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67450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A0D80-483B-4B86-9E41-E82F57A7FC71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BFCB-6F1D-41F8-A75E-A6FFB068C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52624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365125"/>
            <a:ext cx="157734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365125"/>
            <a:ext cx="464058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A0D80-483B-4B86-9E41-E82F57A7FC71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BFCB-6F1D-41F8-A75E-A6FFB068C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49032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A0D80-483B-4B86-9E41-E82F57A7FC71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BFCB-6F1D-41F8-A75E-A6FFB068C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03786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1709740"/>
            <a:ext cx="6309360" cy="2852737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4589465"/>
            <a:ext cx="6309360" cy="1500187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/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A0D80-483B-4B86-9E41-E82F57A7FC71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BFCB-6F1D-41F8-A75E-A6FFB068C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19543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1825625"/>
            <a:ext cx="310896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1825625"/>
            <a:ext cx="310896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A0D80-483B-4B86-9E41-E82F57A7FC71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BFCB-6F1D-41F8-A75E-A6FFB068C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49556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365127"/>
            <a:ext cx="630936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1681163"/>
            <a:ext cx="3094672" cy="823912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2505075"/>
            <a:ext cx="3094672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1681163"/>
            <a:ext cx="3109913" cy="823912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2505075"/>
            <a:ext cx="3109913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A0D80-483B-4B86-9E41-E82F57A7FC71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BFCB-6F1D-41F8-A75E-A6FFB068C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6302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A0D80-483B-4B86-9E41-E82F57A7FC71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BFCB-6F1D-41F8-A75E-A6FFB068C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43914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A0D80-483B-4B86-9E41-E82F57A7FC71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BFCB-6F1D-41F8-A75E-A6FFB068C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6104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457200"/>
            <a:ext cx="2359342" cy="160020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987427"/>
            <a:ext cx="3703320" cy="4873625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2057400"/>
            <a:ext cx="2359342" cy="3811588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A0D80-483B-4B86-9E41-E82F57A7FC71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BFCB-6F1D-41F8-A75E-A6FFB068C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19259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457200"/>
            <a:ext cx="2359342" cy="160020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987427"/>
            <a:ext cx="3703320" cy="4873625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2057400"/>
            <a:ext cx="2359342" cy="3811588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9A0D80-483B-4B86-9E41-E82F57A7FC71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4BBFCB-6F1D-41F8-A75E-A6FFB068C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73930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365127"/>
            <a:ext cx="630936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1825625"/>
            <a:ext cx="630936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6356352"/>
            <a:ext cx="164592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9A0D80-483B-4B86-9E41-E82F57A7FC71}" type="datetimeFigureOut">
              <a:rPr lang="en-US" smtClean="0"/>
              <a:t>5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6356352"/>
            <a:ext cx="246888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6356352"/>
            <a:ext cx="164592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4BBFCB-6F1D-41F8-A75E-A6FFB068C7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88233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2B9D78B-9D7A-6CA6-04EB-B76447B41645}"/>
              </a:ext>
            </a:extLst>
          </p:cNvPr>
          <p:cNvSpPr txBox="1"/>
          <p:nvPr/>
        </p:nvSpPr>
        <p:spPr>
          <a:xfrm>
            <a:off x="85726" y="6273780"/>
            <a:ext cx="25457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Figure 12 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5AFC065C-81F2-0977-E955-D12FEF3558AD}"/>
              </a:ext>
            </a:extLst>
          </p:cNvPr>
          <p:cNvGrpSpPr/>
          <p:nvPr/>
        </p:nvGrpSpPr>
        <p:grpSpPr>
          <a:xfrm>
            <a:off x="2066084" y="1385656"/>
            <a:ext cx="3034445" cy="2373896"/>
            <a:chOff x="3691121" y="1090226"/>
            <a:chExt cx="5057408" cy="3956492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4432FA32-BEA8-A728-AAAC-E1C12A5A70D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349143" y="1675061"/>
              <a:ext cx="3798516" cy="3371657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AD6CA62C-DC48-7F3C-59A0-9B1A5F0D6E8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096000" y="3429000"/>
              <a:ext cx="0" cy="0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CB69FC76-A49E-33DA-DD55-709A9384EF5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914922" y="3114714"/>
              <a:ext cx="361905" cy="314286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B4B25A5A-AD67-8583-F1D9-E51A4046B8F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219977" y="3067095"/>
              <a:ext cx="438095" cy="361905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B5971D3D-0668-7FE3-801C-A94D1213F637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015068" y="3094224"/>
              <a:ext cx="466667" cy="533333"/>
            </a:xfrm>
            <a:prstGeom prst="rect">
              <a:avLst/>
            </a:prstGeom>
          </p:spPr>
        </p:pic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D02C5BB4-381A-7C58-E287-274F098568AE}"/>
                </a:ext>
              </a:extLst>
            </p:cNvPr>
            <p:cNvSpPr/>
            <p:nvPr/>
          </p:nvSpPr>
          <p:spPr>
            <a:xfrm>
              <a:off x="3867150" y="1428750"/>
              <a:ext cx="1247775" cy="828675"/>
            </a:xfrm>
            <a:prstGeom prst="rect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1080" dirty="0"/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604DC64A-44AB-D268-0154-D989CE0EDA83}"/>
                </a:ext>
              </a:extLst>
            </p:cNvPr>
            <p:cNvSpPr/>
            <p:nvPr/>
          </p:nvSpPr>
          <p:spPr>
            <a:xfrm>
              <a:off x="7324725" y="1428749"/>
              <a:ext cx="1247775" cy="828675"/>
            </a:xfrm>
            <a:prstGeom prst="rect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1080" dirty="0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CF839006-1780-89F2-3B5A-9CF34E9905D6}"/>
                </a:ext>
              </a:extLst>
            </p:cNvPr>
            <p:cNvSpPr txBox="1"/>
            <p:nvPr/>
          </p:nvSpPr>
          <p:spPr>
            <a:xfrm>
              <a:off x="4839056" y="2989729"/>
              <a:ext cx="497467" cy="5642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1FB9D78F-A819-615E-0D28-D8257D3A72DD}"/>
                </a:ext>
              </a:extLst>
            </p:cNvPr>
            <p:cNvSpPr txBox="1"/>
            <p:nvPr/>
          </p:nvSpPr>
          <p:spPr>
            <a:xfrm>
              <a:off x="7043276" y="2891202"/>
              <a:ext cx="687153" cy="5642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24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75DA1BF2-8307-D8E7-2AB9-4FAC1DD6BE88}"/>
                </a:ext>
              </a:extLst>
            </p:cNvPr>
            <p:cNvSpPr txBox="1"/>
            <p:nvPr/>
          </p:nvSpPr>
          <p:spPr>
            <a:xfrm>
              <a:off x="5914266" y="2926705"/>
              <a:ext cx="687153" cy="5642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6F2B9B95-E7F5-4443-4AA5-4DCFC197FA30}"/>
                </a:ext>
              </a:extLst>
            </p:cNvPr>
            <p:cNvSpPr txBox="1"/>
            <p:nvPr/>
          </p:nvSpPr>
          <p:spPr>
            <a:xfrm>
              <a:off x="3691121" y="1090226"/>
              <a:ext cx="1423803" cy="13849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    GSEA</a:t>
              </a:r>
            </a:p>
            <a:p>
              <a:pPr algn="ctr"/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   (13)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14B79771-41F8-3E3C-68D9-A778321D2B65}"/>
                </a:ext>
              </a:extLst>
            </p:cNvPr>
            <p:cNvSpPr txBox="1"/>
            <p:nvPr/>
          </p:nvSpPr>
          <p:spPr>
            <a:xfrm>
              <a:off x="7324726" y="1402807"/>
              <a:ext cx="1423803" cy="9746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DAVID</a:t>
              </a:r>
            </a:p>
            <a:p>
              <a:r>
                <a:rPr lang="en-US" sz="1600" dirty="0">
                  <a:latin typeface="Arial" panose="020B0604020202020204" pitchFamily="34" charset="0"/>
                  <a:cs typeface="Arial" panose="020B0604020202020204" pitchFamily="34" charset="0"/>
                </a:rPr>
                <a:t>   (36)</a:t>
              </a:r>
            </a:p>
          </p:txBody>
        </p:sp>
      </p:grp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889808A3-BF41-5839-AB36-1F3DDD1C7A0F}"/>
              </a:ext>
            </a:extLst>
          </p:cNvPr>
          <p:cNvCxnSpPr>
            <a:cxnSpLocks/>
          </p:cNvCxnSpPr>
          <p:nvPr/>
        </p:nvCxnSpPr>
        <p:spPr>
          <a:xfrm>
            <a:off x="3657600" y="2907156"/>
            <a:ext cx="0" cy="852396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48520ACE-BCA4-A672-67AC-8A0A4BAC0A07}"/>
              </a:ext>
            </a:extLst>
          </p:cNvPr>
          <p:cNvSpPr txBox="1"/>
          <p:nvPr/>
        </p:nvSpPr>
        <p:spPr>
          <a:xfrm>
            <a:off x="2114442" y="3791301"/>
            <a:ext cx="3657600" cy="20621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</a:rPr>
              <a:t>KEGG pathway enrichment: </a:t>
            </a:r>
            <a:r>
              <a:rPr lang="en-US" sz="1600" dirty="0">
                <a:latin typeface="Times New Roman" panose="02020603050405020304" pitchFamily="18" charset="0"/>
                <a:ea typeface="Calibri" panose="020F0502020204030204" pitchFamily="34" charset="0"/>
              </a:rPr>
              <a:t>Protein export, DNA replication, Purine metabolism, Pyrimidine metabolism, Oxidative phosphorylation, Huntington's disease, Parkinson's disease, RNA polymerase, Ubiquitin mediated proteolysis, Alzheimer's disease, Glycolysis and Gluconeogenesis.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20720721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95</TotalTime>
  <Words>56</Words>
  <Application>Microsoft Office PowerPoint</Application>
  <PresentationFormat>Custom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seph, Fredrick2</dc:creator>
  <cp:lastModifiedBy>Joseph, Fredrick2</cp:lastModifiedBy>
  <cp:revision>8</cp:revision>
  <dcterms:created xsi:type="dcterms:W3CDTF">2022-10-03T22:48:41Z</dcterms:created>
  <dcterms:modified xsi:type="dcterms:W3CDTF">2023-05-07T21:38:16Z</dcterms:modified>
</cp:coreProperties>
</file>